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53AB29-9840-4643-A10B-2874CAF4C0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35CB66-8859-4619-BD58-A26932135F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0B2290-1D71-47AB-84FC-8DE3609A03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9EECE-B143-4385-A405-BB8A2CFB31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F81CAE-1C82-42BF-860F-2470D26E47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C46C7-CE9E-415B-947B-122C29A3CA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1DD45-D852-4A34-9E06-5BCF8BC539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6E2BA-5AD3-4B1D-92C4-5EF118BDC1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53306-4F7C-4E44-B218-90D86545A3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912F5F-C7B8-4509-BE5B-41822C5E16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3188A1-84B6-4449-A852-B4061C1DE7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E470C-39F4-4C64-B652-A044D15EBA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22C3B4-C052-4696-838E-38F0C9F0F9A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1"/>
          <p:cNvPicPr/>
          <p:nvPr/>
        </p:nvPicPr>
        <p:blipFill>
          <a:blip r:embed="rId1"/>
          <a:srcRect l="6669" t="4714" r="16196" b="58248"/>
          <a:stretch/>
        </p:blipFill>
        <p:spPr>
          <a:xfrm>
            <a:off x="1795320" y="1484280"/>
            <a:ext cx="5297760" cy="3600360"/>
          </a:xfrm>
          <a:prstGeom prst="rect">
            <a:avLst/>
          </a:prstGeom>
          <a:ln w="0">
            <a:noFill/>
          </a:ln>
        </p:spPr>
      </p:pic>
      <p:sp>
        <p:nvSpPr>
          <p:cNvPr id="42" name="Text Box 3"/>
          <p:cNvSpPr/>
          <p:nvPr/>
        </p:nvSpPr>
        <p:spPr>
          <a:xfrm>
            <a:off x="1755360" y="5516640"/>
            <a:ext cx="404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ignment between OsGH9B1 and OsGH9B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826920" y="1971720"/>
          <a:ext cx="7488360" cy="2469960"/>
        </p:xfrm>
        <a:graphic>
          <a:graphicData uri="http://schemas.openxmlformats.org/drawingml/2006/table">
            <a:tbl>
              <a:tblPr/>
              <a:tblGrid>
                <a:gridCol w="1051200"/>
                <a:gridCol w="965160"/>
                <a:gridCol w="2881080"/>
                <a:gridCol w="2590920"/>
              </a:tblGrid>
              <a:tr h="276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rward prim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verse primer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 rowSpan="3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clon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B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CTGCAGGACCGAAGTGTATCGCACATT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GGTACCGTCGTCGGCCCACTC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B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CTGCAGCCGAGACAGTGACACTCTCCT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TCTAGAGTCGTAGAGGAGATCGGACT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GF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GGTACCCCCTCGAGAGATCCCATGGTGAGCAAGGGCGA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GAGCTCCTACGCAGCTCCGGACTTGTA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 rowSpan="3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RT-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B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CCTGCTACTGCGACT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TGACACGGAACGAC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B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CCATCCAGGTGT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GTGCTTGTTGTC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BQ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GTAAGTCCTCAGCC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ACCAGACAACCATAG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Text Box 185"/>
          <p:cNvSpPr/>
          <p:nvPr/>
        </p:nvSpPr>
        <p:spPr>
          <a:xfrm>
            <a:off x="826560" y="1628640"/>
            <a:ext cx="581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The primers used for gene cloning and expression analysis in this study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1-03T10:30:24Z</dcterms:created>
  <dc:creator>微软中国</dc:creator>
  <dc:description/>
  <dc:language>en-US</dc:language>
  <cp:lastModifiedBy>Huang JF</cp:lastModifiedBy>
  <dcterms:modified xsi:type="dcterms:W3CDTF">2018-11-12T08:27:20Z</dcterms:modified>
  <cp:revision>31</cp:revision>
  <dc:subject/>
  <dc:title>幻灯片 1</dc:title>
</cp:coreProperties>
</file>